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5"/>
  </p:notesMasterIdLst>
  <p:sldIdLst>
    <p:sldId id="343" r:id="rId2"/>
    <p:sldId id="344" r:id="rId3"/>
    <p:sldId id="345" r:id="rId4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72833802-FEF1-4C79-8D5D-14CF1EAF98D9}" styleName="淡色スタイル 2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301B821-A1FF-4177-AEE7-76D212191A09}" styleName="中間スタイル 1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06" autoAdjust="0"/>
    <p:restoredTop sz="92077" autoAdjust="0"/>
  </p:normalViewPr>
  <p:slideViewPr>
    <p:cSldViewPr snapToGrid="0">
      <p:cViewPr varScale="1">
        <p:scale>
          <a:sx n="60" d="100"/>
          <a:sy n="60" d="100"/>
        </p:scale>
        <p:origin x="46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ery Important, Some importanc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1!$A$2:$A$6</c:f>
              <c:strCache>
                <c:ptCount val="5"/>
                <c:pt idx="0">
                  <c:v>eGFR</c:v>
                </c:pt>
                <c:pt idx="1">
                  <c:v>Histological severity</c:v>
                </c:pt>
                <c:pt idx="2">
                  <c:v>Degree of hematuria</c:v>
                </c:pt>
                <c:pt idx="3">
                  <c:v>Blood pressure</c:v>
                </c:pt>
                <c:pt idx="4">
                  <c:v>Age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48</c:v>
                </c:pt>
                <c:pt idx="1">
                  <c:v>124</c:v>
                </c:pt>
                <c:pt idx="2">
                  <c:v>40</c:v>
                </c:pt>
                <c:pt idx="3">
                  <c:v>169</c:v>
                </c:pt>
                <c:pt idx="4">
                  <c:v>1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78-4FFF-BB62-A13CBC456AE6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Neither important nor unimportan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1!$A$2:$A$6</c:f>
              <c:strCache>
                <c:ptCount val="5"/>
                <c:pt idx="0">
                  <c:v>eGFR</c:v>
                </c:pt>
                <c:pt idx="1">
                  <c:v>Histological severity</c:v>
                </c:pt>
                <c:pt idx="2">
                  <c:v>Degree of hematuria</c:v>
                </c:pt>
                <c:pt idx="3">
                  <c:v>Blood pressure</c:v>
                </c:pt>
                <c:pt idx="4">
                  <c:v>Age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10</c:v>
                </c:pt>
                <c:pt idx="1">
                  <c:v>16</c:v>
                </c:pt>
                <c:pt idx="2">
                  <c:v>33</c:v>
                </c:pt>
                <c:pt idx="3">
                  <c:v>3</c:v>
                </c:pt>
                <c:pt idx="4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78-4FFF-BB62-A13CBC456AE6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Not very important, Unimportant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A$2:$A$6</c:f>
              <c:strCache>
                <c:ptCount val="5"/>
                <c:pt idx="0">
                  <c:v>eGFR</c:v>
                </c:pt>
                <c:pt idx="1">
                  <c:v>Histological severity</c:v>
                </c:pt>
                <c:pt idx="2">
                  <c:v>Degree of hematuria</c:v>
                </c:pt>
                <c:pt idx="3">
                  <c:v>Blood pressure</c:v>
                </c:pt>
                <c:pt idx="4">
                  <c:v>Age</c:v>
                </c:pt>
              </c:strCache>
            </c:strRef>
          </c:cat>
          <c:val>
            <c:numRef>
              <c:f>Sheet1!$D$2:$D$6</c:f>
              <c:numCache>
                <c:formatCode>General</c:formatCode>
                <c:ptCount val="5"/>
                <c:pt idx="0">
                  <c:v>18</c:v>
                </c:pt>
                <c:pt idx="1">
                  <c:v>36</c:v>
                </c:pt>
                <c:pt idx="2">
                  <c:v>103</c:v>
                </c:pt>
                <c:pt idx="3">
                  <c:v>4</c:v>
                </c:pt>
                <c:pt idx="4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178-4FFF-BB62-A13CBC456A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1707480"/>
        <c:axId val="591708464"/>
      </c:barChart>
      <c:catAx>
        <c:axId val="591707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91708464"/>
        <c:crosses val="autoZero"/>
        <c:auto val="1"/>
        <c:lblAlgn val="ctr"/>
        <c:lblOffset val="100"/>
        <c:noMultiLvlLbl val="0"/>
      </c:catAx>
      <c:valAx>
        <c:axId val="5917084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91707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ery Important, Some importanc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1!$A$2:$A$6</c:f>
              <c:strCache>
                <c:ptCount val="5"/>
                <c:pt idx="0">
                  <c:v>eGFR</c:v>
                </c:pt>
                <c:pt idx="1">
                  <c:v>Histological severity</c:v>
                </c:pt>
                <c:pt idx="2">
                  <c:v>Degree of hematuria</c:v>
                </c:pt>
                <c:pt idx="3">
                  <c:v>Blood pressure</c:v>
                </c:pt>
                <c:pt idx="4">
                  <c:v>Age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53</c:v>
                </c:pt>
                <c:pt idx="1">
                  <c:v>175</c:v>
                </c:pt>
                <c:pt idx="2">
                  <c:v>127</c:v>
                </c:pt>
                <c:pt idx="3">
                  <c:v>86</c:v>
                </c:pt>
                <c:pt idx="4">
                  <c:v>1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78-4FFF-BB62-A13CBC456AE6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Neither important nor unimportan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1!$A$2:$A$6</c:f>
              <c:strCache>
                <c:ptCount val="5"/>
                <c:pt idx="0">
                  <c:v>eGFR</c:v>
                </c:pt>
                <c:pt idx="1">
                  <c:v>Histological severity</c:v>
                </c:pt>
                <c:pt idx="2">
                  <c:v>Degree of hematuria</c:v>
                </c:pt>
                <c:pt idx="3">
                  <c:v>Blood pressure</c:v>
                </c:pt>
                <c:pt idx="4">
                  <c:v>Age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12</c:v>
                </c:pt>
                <c:pt idx="1">
                  <c:v>1</c:v>
                </c:pt>
                <c:pt idx="2">
                  <c:v>18</c:v>
                </c:pt>
                <c:pt idx="3">
                  <c:v>45</c:v>
                </c:pt>
                <c:pt idx="4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78-4FFF-BB62-A13CBC456AE6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Not very important, Unimportant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A$2:$A$6</c:f>
              <c:strCache>
                <c:ptCount val="5"/>
                <c:pt idx="0">
                  <c:v>eGFR</c:v>
                </c:pt>
                <c:pt idx="1">
                  <c:v>Histological severity</c:v>
                </c:pt>
                <c:pt idx="2">
                  <c:v>Degree of hematuria</c:v>
                </c:pt>
                <c:pt idx="3">
                  <c:v>Blood pressure</c:v>
                </c:pt>
                <c:pt idx="4">
                  <c:v>Age</c:v>
                </c:pt>
              </c:strCache>
            </c:strRef>
          </c:cat>
          <c:val>
            <c:numRef>
              <c:f>Sheet1!$D$2:$D$6</c:f>
              <c:numCache>
                <c:formatCode>General</c:formatCode>
                <c:ptCount val="5"/>
                <c:pt idx="0">
                  <c:v>11</c:v>
                </c:pt>
                <c:pt idx="1">
                  <c:v>0</c:v>
                </c:pt>
                <c:pt idx="2">
                  <c:v>31</c:v>
                </c:pt>
                <c:pt idx="3">
                  <c:v>45</c:v>
                </c:pt>
                <c:pt idx="4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178-4FFF-BB62-A13CBC456A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1707480"/>
        <c:axId val="591708464"/>
      </c:barChart>
      <c:catAx>
        <c:axId val="591707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91708464"/>
        <c:crosses val="autoZero"/>
        <c:auto val="1"/>
        <c:lblAlgn val="ctr"/>
        <c:lblOffset val="100"/>
        <c:noMultiLvlLbl val="0"/>
      </c:catAx>
      <c:valAx>
        <c:axId val="5917084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91707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Very Important, Some importanc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1!$A$2:$A$6</c:f>
              <c:strCache>
                <c:ptCount val="5"/>
                <c:pt idx="0">
                  <c:v>eGFR</c:v>
                </c:pt>
                <c:pt idx="1">
                  <c:v>Histological severity</c:v>
                </c:pt>
                <c:pt idx="2">
                  <c:v>Degree of hematuria</c:v>
                </c:pt>
                <c:pt idx="3">
                  <c:v>Blood pressure</c:v>
                </c:pt>
                <c:pt idx="4">
                  <c:v>Age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49</c:v>
                </c:pt>
                <c:pt idx="1">
                  <c:v>163</c:v>
                </c:pt>
                <c:pt idx="2">
                  <c:v>132</c:v>
                </c:pt>
                <c:pt idx="3">
                  <c:v>67</c:v>
                </c:pt>
                <c:pt idx="4">
                  <c:v>1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78-4FFF-BB62-A13CBC456AE6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Neither important nor unimportan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1!$A$2:$A$6</c:f>
              <c:strCache>
                <c:ptCount val="5"/>
                <c:pt idx="0">
                  <c:v>eGFR</c:v>
                </c:pt>
                <c:pt idx="1">
                  <c:v>Histological severity</c:v>
                </c:pt>
                <c:pt idx="2">
                  <c:v>Degree of hematuria</c:v>
                </c:pt>
                <c:pt idx="3">
                  <c:v>Blood pressure</c:v>
                </c:pt>
                <c:pt idx="4">
                  <c:v>Age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17</c:v>
                </c:pt>
                <c:pt idx="1">
                  <c:v>8</c:v>
                </c:pt>
                <c:pt idx="2">
                  <c:v>17</c:v>
                </c:pt>
                <c:pt idx="3">
                  <c:v>47</c:v>
                </c:pt>
                <c:pt idx="4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78-4FFF-BB62-A13CBC456AE6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Not very important, Unimportant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A$2:$A$6</c:f>
              <c:strCache>
                <c:ptCount val="5"/>
                <c:pt idx="0">
                  <c:v>eGFR</c:v>
                </c:pt>
                <c:pt idx="1">
                  <c:v>Histological severity</c:v>
                </c:pt>
                <c:pt idx="2">
                  <c:v>Degree of hematuria</c:v>
                </c:pt>
                <c:pt idx="3">
                  <c:v>Blood pressure</c:v>
                </c:pt>
                <c:pt idx="4">
                  <c:v>Age</c:v>
                </c:pt>
              </c:strCache>
            </c:strRef>
          </c:cat>
          <c:val>
            <c:numRef>
              <c:f>Sheet1!$D$2:$D$6</c:f>
              <c:numCache>
                <c:formatCode>General</c:formatCode>
                <c:ptCount val="5"/>
                <c:pt idx="0">
                  <c:v>10</c:v>
                </c:pt>
                <c:pt idx="1">
                  <c:v>5</c:v>
                </c:pt>
                <c:pt idx="2">
                  <c:v>27</c:v>
                </c:pt>
                <c:pt idx="3">
                  <c:v>62</c:v>
                </c:pt>
                <c:pt idx="4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178-4FFF-BB62-A13CBC456A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1707480"/>
        <c:axId val="591708464"/>
      </c:barChart>
      <c:catAx>
        <c:axId val="591707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91708464"/>
        <c:crosses val="autoZero"/>
        <c:auto val="1"/>
        <c:lblAlgn val="ctr"/>
        <c:lblOffset val="100"/>
        <c:noMultiLvlLbl val="0"/>
      </c:catAx>
      <c:valAx>
        <c:axId val="5917084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91707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4F6035-E4C8-4B49-82DB-9D5ADEA1B2DC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89038" y="1252538"/>
            <a:ext cx="45100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975" y="4821238"/>
            <a:ext cx="5510213" cy="39449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2075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107ED3-FC30-4147-832F-309E637145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478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5219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2198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5984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9398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0490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4745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118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8707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1008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7188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843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6F1061-6811-418C-8DD9-4D826F30A928}" type="datetimeFigureOut">
              <a:rPr kumimoji="1" lang="ja-JP" altLang="en-US" smtClean="0"/>
              <a:t>2023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3AF77-0693-41CB-93C0-02AE7104F2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2632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コンテンツ プレースホルダー 5">
            <a:extLst>
              <a:ext uri="{FF2B5EF4-FFF2-40B4-BE49-F238E27FC236}">
                <a16:creationId xmlns:a16="http://schemas.microsoft.com/office/drawing/2014/main" id="{6940E8F9-6D58-7783-FDB6-288F093C66A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078792183"/>
              </p:ext>
            </p:extLst>
          </p:nvPr>
        </p:nvGraphicFramePr>
        <p:xfrm>
          <a:off x="628650" y="1825625"/>
          <a:ext cx="78867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21A6156-F822-5641-045D-A48A67E657FF}"/>
              </a:ext>
            </a:extLst>
          </p:cNvPr>
          <p:cNvSpPr txBox="1"/>
          <p:nvPr/>
        </p:nvSpPr>
        <p:spPr>
          <a:xfrm>
            <a:off x="198406" y="180460"/>
            <a:ext cx="2640487" cy="383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F5EE36B-3C15-941A-5352-85B714D28B04}"/>
              </a:ext>
            </a:extLst>
          </p:cNvPr>
          <p:cNvSpPr txBox="1"/>
          <p:nvPr/>
        </p:nvSpPr>
        <p:spPr>
          <a:xfrm>
            <a:off x="457200" y="1573823"/>
            <a:ext cx="791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nswers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94066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コンテンツ プレースホルダー 5">
            <a:extLst>
              <a:ext uri="{FF2B5EF4-FFF2-40B4-BE49-F238E27FC236}">
                <a16:creationId xmlns:a16="http://schemas.microsoft.com/office/drawing/2014/main" id="{6940E8F9-6D58-7783-FDB6-288F093C66A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87536912"/>
              </p:ext>
            </p:extLst>
          </p:nvPr>
        </p:nvGraphicFramePr>
        <p:xfrm>
          <a:off x="628650" y="1825625"/>
          <a:ext cx="78867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7089243-F1A5-8A72-8B7C-E56D9C422D58}"/>
              </a:ext>
            </a:extLst>
          </p:cNvPr>
          <p:cNvSpPr txBox="1"/>
          <p:nvPr/>
        </p:nvSpPr>
        <p:spPr>
          <a:xfrm>
            <a:off x="457200" y="1573823"/>
            <a:ext cx="791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nswers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39C03BC-059F-D575-E515-F7B1864E47EF}"/>
              </a:ext>
            </a:extLst>
          </p:cNvPr>
          <p:cNvSpPr txBox="1"/>
          <p:nvPr/>
        </p:nvSpPr>
        <p:spPr>
          <a:xfrm>
            <a:off x="198406" y="180459"/>
            <a:ext cx="2640487" cy="3724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73616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コンテンツ プレースホルダー 5">
            <a:extLst>
              <a:ext uri="{FF2B5EF4-FFF2-40B4-BE49-F238E27FC236}">
                <a16:creationId xmlns:a16="http://schemas.microsoft.com/office/drawing/2014/main" id="{6940E8F9-6D58-7783-FDB6-288F093C66A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26891308"/>
              </p:ext>
            </p:extLst>
          </p:nvPr>
        </p:nvGraphicFramePr>
        <p:xfrm>
          <a:off x="628650" y="1825625"/>
          <a:ext cx="78867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7D0ACD3-CE8D-3EA8-430B-13F9CA929B9E}"/>
              </a:ext>
            </a:extLst>
          </p:cNvPr>
          <p:cNvSpPr txBox="1"/>
          <p:nvPr/>
        </p:nvSpPr>
        <p:spPr>
          <a:xfrm>
            <a:off x="457200" y="1573823"/>
            <a:ext cx="791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nswers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26A843A-5A45-4130-2CB6-4C75702008DE}"/>
              </a:ext>
            </a:extLst>
          </p:cNvPr>
          <p:cNvSpPr txBox="1"/>
          <p:nvPr/>
        </p:nvSpPr>
        <p:spPr>
          <a:xfrm>
            <a:off x="198406" y="180459"/>
            <a:ext cx="27574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253538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37</TotalTime>
  <Words>18</Words>
  <Application>Microsoft Office PowerPoint</Application>
  <PresentationFormat>画面に合わせる (4:3)</PresentationFormat>
  <Paragraphs>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Times New Roman</vt:lpstr>
      <vt:lpstr>1_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zaki Keiichi</dc:creator>
  <cp:lastModifiedBy>鈴木仁</cp:lastModifiedBy>
  <cp:revision>211</cp:revision>
  <cp:lastPrinted>2022-11-11T05:14:01Z</cp:lastPrinted>
  <dcterms:created xsi:type="dcterms:W3CDTF">2022-01-25T06:08:06Z</dcterms:created>
  <dcterms:modified xsi:type="dcterms:W3CDTF">2023-07-29T12:23:28Z</dcterms:modified>
</cp:coreProperties>
</file>